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3B8B7"/>
    <a:srgbClr val="446C91"/>
    <a:srgbClr val="A1B7CD"/>
    <a:srgbClr val="E8F1FA"/>
    <a:srgbClr val="FDE9D9"/>
    <a:srgbClr val="E5EBEE"/>
    <a:srgbClr val="FFF2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68" y="3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C7C41A-5A5A-3191-6C0D-83E1C91120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FDB78E-3C35-0D86-CD21-C107B21837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529179-FC9D-9DDF-FFFF-4624F5521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35FD9F-36FD-6FC5-680E-E78E92ABB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DE0AB1-8B18-FC93-5F19-592074A53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343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8C7410-D8FB-3BC6-D617-CBCC1C0AA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2410FD-3F95-EC5C-927F-B571C2F405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6A9372-6DBA-A436-71D6-2AFEA6E36B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20D9BE-88CC-2934-D3F4-7EBD4D6BA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56400C-CB45-FB24-9A47-08BAAE9CB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325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ECDDA4-301C-0C05-F0F5-F1106F0B85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AACA90-4B51-DCBE-9415-B113CBE3AC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DE0AEE-DF33-7C37-5B46-A674F539F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C511F5-E3DA-3591-3C9C-2E72318DA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3C08E5-8FCC-E289-2831-D68EF50B3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404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C3D315-7FE3-1C53-3EBA-03775072F2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0DD255-74C7-7F6E-EB9E-F1E5F58AE1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BA3851-DD23-B281-183F-9BC1E133D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0B758C-284E-79CF-1EB8-B45BF4908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8123FA-B92C-D206-B375-F021FB41A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78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2AF24-0B09-DAD1-E00B-6ED79CC6F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02A6D2-964D-18AB-4CC7-782217EE2F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760C1F-67A6-D768-D1B3-3EC814904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B139E6-6620-56D7-6C26-BADB15EF9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C0687A-7CE4-7703-D672-898A9C448E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41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9D6371-B134-E03D-5F41-00F82BF8B9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49FC1C-5A14-39CE-0257-FBCF3578A0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2A2816-A8CD-899A-FBBD-D530981EB3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C9358B-478C-1EA4-3783-73B027F88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C056B8-9843-A0D9-5AD6-093014194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9284B3-320F-7CDC-ED54-DB9D473F0E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079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5609B9-4BA3-58D9-0E8B-7D39DA5808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65E529-74C1-D68A-DA9F-B55A9DA9E4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F59A67-447B-516D-16DE-555F07E805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6D9840-3033-956E-234B-F34B5F26D8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481B2FC-A14E-328F-40E4-69A410DA49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04228F-CB8A-94AA-7974-5D318C222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B6A93C6-7278-51C0-6055-4DD69C4C0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CEC344-F123-CF51-0271-7666C8031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64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0E378B-2C48-80F9-4E41-A006878C87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E326842-07AB-668B-64B8-85B6FEDC5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9B00886-FD85-AD37-5BDE-257DF6F4B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42403D9-DFA7-BF46-FCA5-0F43CD129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582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C03C45-C38E-4C5D-C85D-BB046CDE0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97FB5F-E8F7-2618-F1F5-799C75AA1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50DFD0F-E4E7-0515-C19B-817798ED25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05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81B8E-3E50-8BE3-4CDE-A757B09D93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1BDA64-2CF1-066C-7D27-1CBCA97D15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4FEAFA-3493-EC81-C820-C3BA98DC3B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B7A664-ED17-F4DD-8163-3067E3968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4A8896-115D-D861-F167-4B5D08CE23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E27375-0D81-97F6-9F4A-E355D7BAC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832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C4899-3BDF-3523-87CE-B5178B7659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91E3C1-B9F0-EC91-B1DF-2EC7C04311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3D2B8B-9F44-9789-DA30-1C29C10BD3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DF27EF-264D-7ACE-D8E4-81D8C245E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29EC31-3859-150C-25F1-1511610D1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B1A0BD-D252-98DD-FF9B-889707F12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728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D83EE1-7D8B-B029-7E7D-6080479A98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B46E0A-7A2D-9F3B-A40B-5C6B8F9666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57C674-036B-C2A5-084B-516A9D634C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691D4-1096-41CA-BBD2-5043E98E0069}" type="datetimeFigureOut">
              <a:rPr lang="en-US" smtClean="0"/>
              <a:t>11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CEF4E-96A3-ADCE-E97E-81408ADFA9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51F9FE-2A00-28EF-A4CF-E16991B8AD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B7177C-2074-49F2-B4A2-F19AB9C4B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625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7C1104-4709-9C3D-748A-D00A219483A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2977A95-A5EC-DB6F-C33D-260DC59624E7}"/>
              </a:ext>
            </a:extLst>
          </p:cNvPr>
          <p:cNvSpPr txBox="1"/>
          <p:nvPr/>
        </p:nvSpPr>
        <p:spPr>
          <a:xfrm>
            <a:off x="3041872" y="158489"/>
            <a:ext cx="688713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>
                <a:latin typeface="Times New Roman" panose="02020603050405020304" pitchFamily="18" charset="0"/>
                <a:ea typeface="宋体" panose="02010600030101010101" pitchFamily="2" charset="-122"/>
              </a:rPr>
              <a:t>Post-Stroke Anxiety &amp; Depression: Pathophysiological Cascade</a:t>
            </a:r>
          </a:p>
        </p:txBody>
      </p:sp>
      <p:sp>
        <p:nvSpPr>
          <p:cNvPr id="6" name="Flowchart: Alternate Process 5">
            <a:extLst>
              <a:ext uri="{FF2B5EF4-FFF2-40B4-BE49-F238E27FC236}">
                <a16:creationId xmlns:a16="http://schemas.microsoft.com/office/drawing/2014/main" id="{1E2932B0-E431-B2EC-FDF4-D103F33C36D0}"/>
              </a:ext>
            </a:extLst>
          </p:cNvPr>
          <p:cNvSpPr/>
          <p:nvPr/>
        </p:nvSpPr>
        <p:spPr>
          <a:xfrm>
            <a:off x="4724758" y="716379"/>
            <a:ext cx="2742479" cy="589389"/>
          </a:xfrm>
          <a:prstGeom prst="flowChartAlternateProcess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rgbClr val="446C9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oke Event(Ischemic / Hemorrhagic)</a:t>
            </a:r>
          </a:p>
        </p:txBody>
      </p:sp>
      <p:sp>
        <p:nvSpPr>
          <p:cNvPr id="7" name="Flowchart: Alternate Process 6">
            <a:extLst>
              <a:ext uri="{FF2B5EF4-FFF2-40B4-BE49-F238E27FC236}">
                <a16:creationId xmlns:a16="http://schemas.microsoft.com/office/drawing/2014/main" id="{43E041C9-FD3E-27E1-2466-E77258EA019F}"/>
              </a:ext>
            </a:extLst>
          </p:cNvPr>
          <p:cNvSpPr/>
          <p:nvPr/>
        </p:nvSpPr>
        <p:spPr>
          <a:xfrm>
            <a:off x="3826881" y="4485736"/>
            <a:ext cx="4538235" cy="1043559"/>
          </a:xfrm>
          <a:prstGeom prst="flowChartAlternateProcess">
            <a:avLst/>
          </a:prstGeom>
          <a:solidFill>
            <a:srgbClr val="FDE9D9"/>
          </a:solidFill>
          <a:ln>
            <a:solidFill>
              <a:srgbClr val="E3B8B7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just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havioral &amp; Social Factors</a:t>
            </a:r>
          </a:p>
          <a:p>
            <a:pPr algn="just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Activity avoidance, social withdrawal</a:t>
            </a:r>
          </a:p>
          <a:p>
            <a:pPr algn="just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Communication barriers, role loss</a:t>
            </a:r>
          </a:p>
          <a:p>
            <a:pPr algn="just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Caregiver burden &amp; limited social support</a:t>
            </a:r>
          </a:p>
          <a:p>
            <a:pPr algn="just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Environmental stress (financial, lifestyle changes)</a:t>
            </a:r>
          </a:p>
        </p:txBody>
      </p:sp>
      <p:sp>
        <p:nvSpPr>
          <p:cNvPr id="10" name="Flowchart: Alternate Process 9">
            <a:extLst>
              <a:ext uri="{FF2B5EF4-FFF2-40B4-BE49-F238E27FC236}">
                <a16:creationId xmlns:a16="http://schemas.microsoft.com/office/drawing/2014/main" id="{65FCA202-4628-CB80-D4E5-ABD18E5477D8}"/>
              </a:ext>
            </a:extLst>
          </p:cNvPr>
          <p:cNvSpPr/>
          <p:nvPr/>
        </p:nvSpPr>
        <p:spPr>
          <a:xfrm>
            <a:off x="3803451" y="3165020"/>
            <a:ext cx="4585098" cy="1134374"/>
          </a:xfrm>
          <a:prstGeom prst="flowChartAlternateProcess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rgbClr val="446C9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gnitive &amp; Psychological Mechanisms</a:t>
            </a:r>
          </a:p>
          <a:p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Executive dysfunction, attentional deficits</a:t>
            </a:r>
          </a:p>
          <a:p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Negative cognitive schemas (catastrophizing, hopelessness)</a:t>
            </a:r>
          </a:p>
          <a:p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Low self-efficacy &amp; impaired coping</a:t>
            </a:r>
          </a:p>
          <a:p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Heightened perceived threat, uncertainty</a:t>
            </a:r>
          </a:p>
        </p:txBody>
      </p:sp>
      <p:sp>
        <p:nvSpPr>
          <p:cNvPr id="11" name="Flowchart: Alternate Process 10">
            <a:extLst>
              <a:ext uri="{FF2B5EF4-FFF2-40B4-BE49-F238E27FC236}">
                <a16:creationId xmlns:a16="http://schemas.microsoft.com/office/drawing/2014/main" id="{1603D22D-E582-1EFE-200D-28923DD39C41}"/>
              </a:ext>
            </a:extLst>
          </p:cNvPr>
          <p:cNvSpPr/>
          <p:nvPr/>
        </p:nvSpPr>
        <p:spPr>
          <a:xfrm>
            <a:off x="3803450" y="1510898"/>
            <a:ext cx="4585099" cy="1431995"/>
          </a:xfrm>
          <a:prstGeom prst="flowChartAlternateProcess">
            <a:avLst/>
          </a:prstGeom>
          <a:solidFill>
            <a:srgbClr val="E3B8B7"/>
          </a:solidFill>
          <a:ln>
            <a:solidFill>
              <a:srgbClr val="446C9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urobiological Disruptions</a:t>
            </a:r>
            <a:b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Structural damage to emotion-regulation circuits (PFC–Limbic–Thalamic)</a:t>
            </a:r>
          </a:p>
          <a:p>
            <a:pPr algn="just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Monoamine imbalance (↓Serotonin, ↓Norepinephrine, ↓Dopamine)</a:t>
            </a:r>
          </a:p>
          <a:p>
            <a:pPr algn="just"/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Neuroinflammation (↑IL-6, ↑TNF-</a:t>
            </a:r>
            <a:r>
              <a:rPr lang="el-GR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, </a:t>
            </a: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croglial activation)</a:t>
            </a:r>
          </a:p>
          <a:p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Oxidative stress &amp; mitochondrial dysfunction</a:t>
            </a:r>
          </a:p>
          <a:p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• Reduced neurotrophic support (↓BDNF)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7A7DC3E-45B4-D39B-06BD-AC40A8C0D4D2}"/>
              </a:ext>
            </a:extLst>
          </p:cNvPr>
          <p:cNvCxnSpPr>
            <a:cxnSpLocks/>
            <a:endCxn id="37" idx="2"/>
          </p:cNvCxnSpPr>
          <p:nvPr/>
        </p:nvCxnSpPr>
        <p:spPr>
          <a:xfrm flipH="1" flipV="1">
            <a:off x="8382932" y="2194560"/>
            <a:ext cx="291931" cy="15070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Flowchart: Alternate Process 7">
            <a:extLst>
              <a:ext uri="{FF2B5EF4-FFF2-40B4-BE49-F238E27FC236}">
                <a16:creationId xmlns:a16="http://schemas.microsoft.com/office/drawing/2014/main" id="{E29212B6-3311-8690-B6DA-9C62665F7A91}"/>
              </a:ext>
            </a:extLst>
          </p:cNvPr>
          <p:cNvSpPr/>
          <p:nvPr/>
        </p:nvSpPr>
        <p:spPr>
          <a:xfrm>
            <a:off x="3882731" y="5751677"/>
            <a:ext cx="4482385" cy="957700"/>
          </a:xfrm>
          <a:prstGeom prst="flowChartAlternateProcess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rgbClr val="E3B8B7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Post-Stroke Anxiety &amp; Depression (PSAD)</a:t>
            </a:r>
          </a:p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• Persistent anxiety, fear, rumination</a:t>
            </a:r>
          </a:p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• Depressive mood, anhedonia, emotional instability</a:t>
            </a:r>
          </a:p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• Impaired rehabilitation engagement</a:t>
            </a:r>
          </a:p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• Worse functional outcomes &amp; quality of lif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11B5DF8-4AD5-50F0-0359-CB6DD0426608}"/>
              </a:ext>
            </a:extLst>
          </p:cNvPr>
          <p:cNvSpPr txBox="1"/>
          <p:nvPr/>
        </p:nvSpPr>
        <p:spPr>
          <a:xfrm rot="5400000">
            <a:off x="8276782" y="3385268"/>
            <a:ext cx="13553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Vicious Cycle</a:t>
            </a:r>
            <a:endParaRPr 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Freeform: Shape 36">
            <a:extLst>
              <a:ext uri="{FF2B5EF4-FFF2-40B4-BE49-F238E27FC236}">
                <a16:creationId xmlns:a16="http://schemas.microsoft.com/office/drawing/2014/main" id="{0AF6FBC0-7884-2F06-6030-1DC9A6C47A5F}"/>
              </a:ext>
            </a:extLst>
          </p:cNvPr>
          <p:cNvSpPr/>
          <p:nvPr/>
        </p:nvSpPr>
        <p:spPr>
          <a:xfrm>
            <a:off x="8357830" y="2194560"/>
            <a:ext cx="916226" cy="4013735"/>
          </a:xfrm>
          <a:custGeom>
            <a:avLst/>
            <a:gdLst>
              <a:gd name="connsiteX0" fmla="*/ 0 w 1405310"/>
              <a:gd name="connsiteY0" fmla="*/ 4013735 h 4013735"/>
              <a:gd name="connsiteX1" fmla="*/ 1405288 w 1405310"/>
              <a:gd name="connsiteY1" fmla="*/ 1039529 h 4013735"/>
              <a:gd name="connsiteX2" fmla="*/ 38501 w 1405310"/>
              <a:gd name="connsiteY2" fmla="*/ 0 h 4013735"/>
              <a:gd name="connsiteX3" fmla="*/ 38501 w 1405310"/>
              <a:gd name="connsiteY3" fmla="*/ 0 h 4013735"/>
              <a:gd name="connsiteX4" fmla="*/ 96253 w 1405310"/>
              <a:gd name="connsiteY4" fmla="*/ 0 h 40137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405310" h="4013735">
                <a:moveTo>
                  <a:pt x="0" y="4013735"/>
                </a:moveTo>
                <a:cubicBezTo>
                  <a:pt x="699435" y="2861110"/>
                  <a:pt x="1398871" y="1708485"/>
                  <a:pt x="1405288" y="1039529"/>
                </a:cubicBezTo>
                <a:cubicBezTo>
                  <a:pt x="1411705" y="370573"/>
                  <a:pt x="38501" y="0"/>
                  <a:pt x="38501" y="0"/>
                </a:cubicBezTo>
                <a:lnTo>
                  <a:pt x="38501" y="0"/>
                </a:lnTo>
                <a:lnTo>
                  <a:pt x="96253" y="0"/>
                </a:lnTo>
              </a:path>
            </a:pathLst>
          </a:cu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D20D8CB3-BD7C-4B41-A2F9-8EBB32B631D1}"/>
              </a:ext>
            </a:extLst>
          </p:cNvPr>
          <p:cNvCxnSpPr>
            <a:stCxn id="6" idx="2"/>
            <a:endCxn id="11" idx="0"/>
          </p:cNvCxnSpPr>
          <p:nvPr/>
        </p:nvCxnSpPr>
        <p:spPr>
          <a:xfrm>
            <a:off x="6095998" y="1305768"/>
            <a:ext cx="2" cy="20513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7827BC2C-5703-EC33-5F4D-7130356C2011}"/>
              </a:ext>
            </a:extLst>
          </p:cNvPr>
          <p:cNvCxnSpPr>
            <a:stCxn id="11" idx="2"/>
            <a:endCxn id="10" idx="0"/>
          </p:cNvCxnSpPr>
          <p:nvPr/>
        </p:nvCxnSpPr>
        <p:spPr>
          <a:xfrm>
            <a:off x="6096000" y="2942893"/>
            <a:ext cx="0" cy="22212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40304036-7071-8746-3D6C-2A7D8A7C5A62}"/>
              </a:ext>
            </a:extLst>
          </p:cNvPr>
          <p:cNvCxnSpPr>
            <a:stCxn id="10" idx="2"/>
            <a:endCxn id="7" idx="0"/>
          </p:cNvCxnSpPr>
          <p:nvPr/>
        </p:nvCxnSpPr>
        <p:spPr>
          <a:xfrm flipH="1">
            <a:off x="6095999" y="4299394"/>
            <a:ext cx="1" cy="18634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EF2F96FD-F6F6-0031-8C76-E0A2469F328A}"/>
              </a:ext>
            </a:extLst>
          </p:cNvPr>
          <p:cNvCxnSpPr/>
          <p:nvPr/>
        </p:nvCxnSpPr>
        <p:spPr>
          <a:xfrm flipH="1">
            <a:off x="6104020" y="5549074"/>
            <a:ext cx="1" cy="18634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424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9CBCB0-4C72-0653-3ECF-C097524389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F87158E-3C8E-3E2E-1893-E3829BB4247E}"/>
              </a:ext>
            </a:extLst>
          </p:cNvPr>
          <p:cNvSpPr txBox="1"/>
          <p:nvPr/>
        </p:nvSpPr>
        <p:spPr>
          <a:xfrm>
            <a:off x="3666902" y="937786"/>
            <a:ext cx="60990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>
                <a:latin typeface="Times New Roman" panose="02020603050405020304" pitchFamily="18" charset="0"/>
                <a:ea typeface="宋体" panose="02010600030101010101" pitchFamily="2" charset="-122"/>
              </a:rPr>
              <a:t>Integrated Multi Modal Management Framework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F5141E9C-A0C4-D4DB-0BE2-70AA198090F0}"/>
              </a:ext>
            </a:extLst>
          </p:cNvPr>
          <p:cNvGrpSpPr/>
          <p:nvPr/>
        </p:nvGrpSpPr>
        <p:grpSpPr>
          <a:xfrm>
            <a:off x="1728208" y="1608140"/>
            <a:ext cx="8887283" cy="3490242"/>
            <a:chOff x="1719741" y="1498073"/>
            <a:chExt cx="8887283" cy="3490242"/>
          </a:xfrm>
        </p:grpSpPr>
        <p:sp>
          <p:nvSpPr>
            <p:cNvPr id="6" name="Flowchart: Alternate Process 5">
              <a:extLst>
                <a:ext uri="{FF2B5EF4-FFF2-40B4-BE49-F238E27FC236}">
                  <a16:creationId xmlns:a16="http://schemas.microsoft.com/office/drawing/2014/main" id="{4A11F3A1-3AEB-8CC0-28C0-A14243044C9B}"/>
                </a:ext>
              </a:extLst>
            </p:cNvPr>
            <p:cNvSpPr/>
            <p:nvPr/>
          </p:nvSpPr>
          <p:spPr>
            <a:xfrm>
              <a:off x="1719741" y="1498073"/>
              <a:ext cx="2191859" cy="974193"/>
            </a:xfrm>
            <a:prstGeom prst="flowChartAlternateProcess">
              <a:avLst/>
            </a:prstGeom>
            <a:solidFill>
              <a:srgbClr val="E8F1FA"/>
            </a:solidFill>
            <a:ln>
              <a:solidFill>
                <a:srgbClr val="446C9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armacotherapy</a:t>
              </a:r>
            </a:p>
            <a:p>
              <a:endPara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SRIs / SNRIs</a:t>
              </a: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nitor adverse effects</a:t>
              </a:r>
            </a:p>
            <a:p>
              <a:endPara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Flowchart: Alternate Process 6">
              <a:extLst>
                <a:ext uri="{FF2B5EF4-FFF2-40B4-BE49-F238E27FC236}">
                  <a16:creationId xmlns:a16="http://schemas.microsoft.com/office/drawing/2014/main" id="{7FD67247-E018-8E62-1FBC-289CE7C248F1}"/>
                </a:ext>
              </a:extLst>
            </p:cNvPr>
            <p:cNvSpPr/>
            <p:nvPr/>
          </p:nvSpPr>
          <p:spPr>
            <a:xfrm>
              <a:off x="4836998" y="2641547"/>
              <a:ext cx="2910002" cy="1317072"/>
            </a:xfrm>
            <a:prstGeom prst="flowChartAlternateProcess">
              <a:avLst/>
            </a:prstGeom>
            <a:solidFill>
              <a:srgbClr val="FDE9D9"/>
            </a:solidFill>
            <a:ln>
              <a:solidFill>
                <a:srgbClr val="E3B8B7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nagement Goals</a:t>
              </a:r>
            </a:p>
            <a:p>
              <a:endParaRPr lang="en-US" sz="12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Reduce depressive and anxious symptoms</a:t>
              </a:r>
            </a:p>
            <a:p>
              <a:r>
                <a:rPr 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Improve recovery, cognition and QoL</a:t>
              </a:r>
            </a:p>
            <a:p>
              <a:r>
                <a:rPr 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Enhance participation and independence</a:t>
              </a:r>
            </a:p>
            <a:p>
              <a:pPr algn="ctr"/>
              <a:endPara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lowchart: Alternate Process 9">
              <a:extLst>
                <a:ext uri="{FF2B5EF4-FFF2-40B4-BE49-F238E27FC236}">
                  <a16:creationId xmlns:a16="http://schemas.microsoft.com/office/drawing/2014/main" id="{B643D1E9-7E87-D817-D520-509E89D5D768}"/>
                </a:ext>
              </a:extLst>
            </p:cNvPr>
            <p:cNvSpPr/>
            <p:nvPr/>
          </p:nvSpPr>
          <p:spPr>
            <a:xfrm>
              <a:off x="1719741" y="4048466"/>
              <a:ext cx="2173216" cy="939849"/>
            </a:xfrm>
            <a:prstGeom prst="flowChartAlternateProcess">
              <a:avLst/>
            </a:prstGeom>
            <a:solidFill>
              <a:srgbClr val="E8F1FA"/>
            </a:solidFill>
            <a:ln>
              <a:solidFill>
                <a:srgbClr val="446C9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igital Health</a:t>
              </a:r>
            </a:p>
            <a:p>
              <a:endPara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line CBT</a:t>
              </a: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ele-rehabilitation / apps</a:t>
              </a:r>
            </a:p>
            <a:p>
              <a:pPr algn="ctr"/>
              <a:endPara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lowchart: Alternate Process 10">
              <a:extLst>
                <a:ext uri="{FF2B5EF4-FFF2-40B4-BE49-F238E27FC236}">
                  <a16:creationId xmlns:a16="http://schemas.microsoft.com/office/drawing/2014/main" id="{842645B4-1591-EA31-BECA-1073F7D55A7F}"/>
                </a:ext>
              </a:extLst>
            </p:cNvPr>
            <p:cNvSpPr/>
            <p:nvPr/>
          </p:nvSpPr>
          <p:spPr>
            <a:xfrm>
              <a:off x="1719741" y="2675440"/>
              <a:ext cx="2191859" cy="1051758"/>
            </a:xfrm>
            <a:prstGeom prst="flowChartAlternateProcess">
              <a:avLst/>
            </a:prstGeom>
            <a:solidFill>
              <a:srgbClr val="E8F1FA"/>
            </a:solidFill>
            <a:ln>
              <a:solidFill>
                <a:srgbClr val="446C9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ercise &amp; Physical Therapy</a:t>
              </a:r>
            </a:p>
            <a:p>
              <a:endPara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erobic &amp; resistance training</a:t>
              </a: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TMS, tDCS, VR rehab</a:t>
              </a:r>
            </a:p>
            <a:p>
              <a:pPr algn="ctr"/>
              <a:endPara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4F31CE20-7157-D4DC-581C-9E6F9D3EE291}"/>
                </a:ext>
              </a:extLst>
            </p:cNvPr>
            <p:cNvCxnSpPr>
              <a:cxnSpLocks/>
              <a:stCxn id="6" idx="3"/>
              <a:endCxn id="7" idx="1"/>
            </p:cNvCxnSpPr>
            <p:nvPr/>
          </p:nvCxnSpPr>
          <p:spPr>
            <a:xfrm>
              <a:off x="3911600" y="1985170"/>
              <a:ext cx="925398" cy="1314913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F017F89D-FC35-B071-D90A-84D3972F2E8D}"/>
                </a:ext>
              </a:extLst>
            </p:cNvPr>
            <p:cNvCxnSpPr>
              <a:cxnSpLocks/>
              <a:stCxn id="11" idx="3"/>
            </p:cNvCxnSpPr>
            <p:nvPr/>
          </p:nvCxnSpPr>
          <p:spPr>
            <a:xfrm>
              <a:off x="3911600" y="3201319"/>
              <a:ext cx="860918" cy="98764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F7052719-4A66-A68A-B8F8-8A80A9630A87}"/>
                </a:ext>
              </a:extLst>
            </p:cNvPr>
            <p:cNvCxnSpPr>
              <a:cxnSpLocks/>
              <a:stCxn id="10" idx="3"/>
              <a:endCxn id="7" idx="1"/>
            </p:cNvCxnSpPr>
            <p:nvPr/>
          </p:nvCxnSpPr>
          <p:spPr>
            <a:xfrm flipV="1">
              <a:off x="3892957" y="3300083"/>
              <a:ext cx="944041" cy="1218308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Flowchart: Alternate Process 11">
              <a:extLst>
                <a:ext uri="{FF2B5EF4-FFF2-40B4-BE49-F238E27FC236}">
                  <a16:creationId xmlns:a16="http://schemas.microsoft.com/office/drawing/2014/main" id="{070CC26F-EDA0-7F22-DE21-B42F150B440D}"/>
                </a:ext>
              </a:extLst>
            </p:cNvPr>
            <p:cNvSpPr/>
            <p:nvPr/>
          </p:nvSpPr>
          <p:spPr>
            <a:xfrm>
              <a:off x="8433808" y="1616679"/>
              <a:ext cx="2173216" cy="939849"/>
            </a:xfrm>
            <a:prstGeom prst="flowChartAlternateProcess">
              <a:avLst/>
            </a:prstGeom>
            <a:solidFill>
              <a:srgbClr val="E8F1FA"/>
            </a:solidFill>
            <a:ln>
              <a:solidFill>
                <a:srgbClr val="446C9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ychological Therapies</a:t>
              </a:r>
            </a:p>
            <a:p>
              <a:endPara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BT / MBCT / MBSR</a:t>
              </a: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tivational interviewing</a:t>
              </a:r>
            </a:p>
          </p:txBody>
        </p:sp>
        <p:sp>
          <p:nvSpPr>
            <p:cNvPr id="13" name="Flowchart: Alternate Process 12">
              <a:extLst>
                <a:ext uri="{FF2B5EF4-FFF2-40B4-BE49-F238E27FC236}">
                  <a16:creationId xmlns:a16="http://schemas.microsoft.com/office/drawing/2014/main" id="{3612F182-C52B-CA36-3C3E-ACF1D6659071}"/>
                </a:ext>
              </a:extLst>
            </p:cNvPr>
            <p:cNvSpPr/>
            <p:nvPr/>
          </p:nvSpPr>
          <p:spPr>
            <a:xfrm>
              <a:off x="8433808" y="2830158"/>
              <a:ext cx="2173216" cy="939849"/>
            </a:xfrm>
            <a:prstGeom prst="flowChartAlternateProcess">
              <a:avLst/>
            </a:prstGeom>
            <a:solidFill>
              <a:srgbClr val="E8F1FA"/>
            </a:solidFill>
            <a:ln>
              <a:solidFill>
                <a:srgbClr val="446C9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cial &amp; Family Support</a:t>
              </a: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regiver support</a:t>
              </a: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cial reintegration</a:t>
              </a:r>
            </a:p>
          </p:txBody>
        </p:sp>
        <p:sp>
          <p:nvSpPr>
            <p:cNvPr id="15" name="Flowchart: Alternate Process 14">
              <a:extLst>
                <a:ext uri="{FF2B5EF4-FFF2-40B4-BE49-F238E27FC236}">
                  <a16:creationId xmlns:a16="http://schemas.microsoft.com/office/drawing/2014/main" id="{107632CF-5E9B-C63A-D152-90AEFF32F545}"/>
                </a:ext>
              </a:extLst>
            </p:cNvPr>
            <p:cNvSpPr/>
            <p:nvPr/>
          </p:nvSpPr>
          <p:spPr>
            <a:xfrm>
              <a:off x="8433808" y="4043637"/>
              <a:ext cx="2173216" cy="939849"/>
            </a:xfrm>
            <a:prstGeom prst="flowChartAlternateProcess">
              <a:avLst/>
            </a:prstGeom>
            <a:solidFill>
              <a:srgbClr val="E8F1FA"/>
            </a:solidFill>
            <a:ln>
              <a:solidFill>
                <a:srgbClr val="446C9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disciplinary Care</a:t>
              </a:r>
            </a:p>
            <a:p>
              <a:endParaRPr lang="en-US" sz="12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euro + Psych + Rehab team</a:t>
              </a:r>
            </a:p>
            <a:p>
              <a:r>
                <a:rPr lang="en-US" sz="12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tegrated service model</a:t>
              </a:r>
            </a:p>
          </p:txBody>
        </p: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E3BC21AF-4A31-512A-5373-416BB141DEEA}"/>
                </a:ext>
              </a:extLst>
            </p:cNvPr>
            <p:cNvCxnSpPr>
              <a:stCxn id="12" idx="1"/>
              <a:endCxn id="7" idx="3"/>
            </p:cNvCxnSpPr>
            <p:nvPr/>
          </p:nvCxnSpPr>
          <p:spPr>
            <a:xfrm flipH="1">
              <a:off x="7747000" y="2086604"/>
              <a:ext cx="686808" cy="121347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088E3A0B-8E62-8CA3-A58C-82CDD0636C5B}"/>
                </a:ext>
              </a:extLst>
            </p:cNvPr>
            <p:cNvCxnSpPr>
              <a:cxnSpLocks/>
              <a:stCxn id="13" idx="1"/>
            </p:cNvCxnSpPr>
            <p:nvPr/>
          </p:nvCxnSpPr>
          <p:spPr>
            <a:xfrm flipH="1">
              <a:off x="7797802" y="3300083"/>
              <a:ext cx="63600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1B293416-7F4D-0515-60A4-F84C1B42B01A}"/>
                </a:ext>
              </a:extLst>
            </p:cNvPr>
            <p:cNvCxnSpPr>
              <a:cxnSpLocks/>
              <a:stCxn id="15" idx="1"/>
              <a:endCxn id="7" idx="3"/>
            </p:cNvCxnSpPr>
            <p:nvPr/>
          </p:nvCxnSpPr>
          <p:spPr>
            <a:xfrm flipH="1" flipV="1">
              <a:off x="7747000" y="3300083"/>
              <a:ext cx="686808" cy="1213479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87198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</TotalTime>
  <Words>247</Words>
  <Application>Microsoft Office PowerPoint</Application>
  <PresentationFormat>Widescreen</PresentationFormat>
  <Paragraphs>5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 PENG</dc:creator>
  <cp:lastModifiedBy>YAN PENG</cp:lastModifiedBy>
  <cp:revision>8</cp:revision>
  <dcterms:created xsi:type="dcterms:W3CDTF">2025-11-18T04:08:07Z</dcterms:created>
  <dcterms:modified xsi:type="dcterms:W3CDTF">2025-11-25T04:56:54Z</dcterms:modified>
</cp:coreProperties>
</file>